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68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7180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99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02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647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98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615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067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6010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793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98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7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435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9489" y="-548857"/>
            <a:ext cx="5700293" cy="7837903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164714" y="4440614"/>
            <a:ext cx="10977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418096" y="4613045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矩形 3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4325267" y="4312309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tabLst>
                <a:tab pos="1255713" algn="l"/>
              </a:tabLst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664482" y="4616305"/>
            <a:ext cx="7225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5037272" y="4555147"/>
            <a:ext cx="853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1983540" y="1012959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092037" y="5065566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3092037" y="5827566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" name="组合 17"/>
          <p:cNvGrpSpPr/>
          <p:nvPr/>
        </p:nvGrpSpPr>
        <p:grpSpPr>
          <a:xfrm>
            <a:off x="3056037" y="4601313"/>
            <a:ext cx="580831" cy="276999"/>
            <a:chOff x="-4002962" y="10215563"/>
            <a:chExt cx="580831" cy="276999"/>
          </a:xfrm>
        </p:grpSpPr>
        <p:sp>
          <p:nvSpPr>
            <p:cNvPr id="19" name="矩形 18"/>
            <p:cNvSpPr/>
            <p:nvPr/>
          </p:nvSpPr>
          <p:spPr>
            <a:xfrm>
              <a:off x="-4002962" y="10215563"/>
              <a:ext cx="5421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40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矩形 20"/>
          <p:cNvSpPr/>
          <p:nvPr/>
        </p:nvSpPr>
        <p:spPr>
          <a:xfrm>
            <a:off x="4255317" y="5163726"/>
            <a:ext cx="1332779" cy="306155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842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7197" y="-1185250"/>
            <a:ext cx="5849636" cy="804325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160388" y="3838294"/>
            <a:ext cx="10977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413770" y="4010725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矩形 3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4320941" y="3709989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tabLst>
                <a:tab pos="1255713" algn="l"/>
              </a:tabLst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660156" y="4013985"/>
            <a:ext cx="7225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5032946" y="3952827"/>
            <a:ext cx="853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2150735" y="1196614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2911256" y="5324469"/>
            <a:ext cx="670376" cy="276999"/>
            <a:chOff x="-4088306" y="10215563"/>
            <a:chExt cx="670376" cy="276999"/>
          </a:xfrm>
        </p:grpSpPr>
        <p:sp>
          <p:nvSpPr>
            <p:cNvPr id="13" name="矩形 12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矩形 14"/>
          <p:cNvSpPr/>
          <p:nvPr/>
        </p:nvSpPr>
        <p:spPr>
          <a:xfrm>
            <a:off x="4283733" y="4600170"/>
            <a:ext cx="1332779" cy="306155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08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313" y="-1623824"/>
            <a:ext cx="5928696" cy="8151957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5452398" y="4310784"/>
            <a:ext cx="10977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5705780" y="4483215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矩形 3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5612951" y="4182479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tabLst>
                <a:tab pos="1255713" algn="l"/>
              </a:tabLst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5952166" y="4486475"/>
            <a:ext cx="7225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6324956" y="4425317"/>
            <a:ext cx="853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2122436" y="1092112"/>
            <a:ext cx="17577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RKDC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Ser2056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4309671" y="6081260"/>
            <a:ext cx="670376" cy="276999"/>
            <a:chOff x="-4088306" y="10215563"/>
            <a:chExt cx="670376" cy="276999"/>
          </a:xfrm>
        </p:grpSpPr>
        <p:sp>
          <p:nvSpPr>
            <p:cNvPr id="12" name="矩形 11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矩形 14"/>
          <p:cNvSpPr/>
          <p:nvPr/>
        </p:nvSpPr>
        <p:spPr>
          <a:xfrm>
            <a:off x="5635953" y="4954296"/>
            <a:ext cx="1332779" cy="335109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097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733" y="-996930"/>
            <a:ext cx="6001618" cy="8252225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213907" y="2933396"/>
            <a:ext cx="109775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B63470F8-8068-46C9-901B-86F7AE62C14B}"/>
              </a:ext>
            </a:extLst>
          </p:cNvPr>
          <p:cNvCxnSpPr>
            <a:cxnSpLocks/>
          </p:cNvCxnSpPr>
          <p:nvPr/>
        </p:nvCxnSpPr>
        <p:spPr>
          <a:xfrm>
            <a:off x="4467289" y="3105827"/>
            <a:ext cx="1170000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" name="矩形 3">
            <a:extLst>
              <a:ext uri="{FF2B5EF4-FFF2-40B4-BE49-F238E27FC236}">
                <a16:creationId xmlns:a16="http://schemas.microsoft.com/office/drawing/2014/main" id="{E1DB421E-9ACF-464C-8ACB-D1AB43B55ABB}"/>
              </a:ext>
            </a:extLst>
          </p:cNvPr>
          <p:cNvSpPr/>
          <p:nvPr/>
        </p:nvSpPr>
        <p:spPr>
          <a:xfrm>
            <a:off x="4374460" y="2805091"/>
            <a:ext cx="1535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tabLst>
                <a:tab pos="1255713" algn="l"/>
              </a:tabLst>
            </a:pP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Pa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Tu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8988T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4713675" y="3109087"/>
            <a:ext cx="7225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2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7ED4BE5C-CEFD-4FEE-B154-600181E1D326}"/>
              </a:ext>
            </a:extLst>
          </p:cNvPr>
          <p:cNvSpPr/>
          <p:nvPr/>
        </p:nvSpPr>
        <p:spPr>
          <a:xfrm rot="17430996">
            <a:off x="5086465" y="3047929"/>
            <a:ext cx="853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sg3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27145F1-DEF5-43BB-BF9A-9191F1AFAE2D}"/>
              </a:ext>
            </a:extLst>
          </p:cNvPr>
          <p:cNvSpPr/>
          <p:nvPr/>
        </p:nvSpPr>
        <p:spPr>
          <a:xfrm>
            <a:off x="2076138" y="1027337"/>
            <a:ext cx="68480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649606" y="4115102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3684330" y="4612813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" name="组合 18"/>
          <p:cNvGrpSpPr/>
          <p:nvPr/>
        </p:nvGrpSpPr>
        <p:grpSpPr>
          <a:xfrm>
            <a:off x="3687456" y="5041076"/>
            <a:ext cx="585417" cy="276999"/>
            <a:chOff x="-4002962" y="10215563"/>
            <a:chExt cx="585417" cy="276999"/>
          </a:xfrm>
        </p:grpSpPr>
        <p:sp>
          <p:nvSpPr>
            <p:cNvPr id="20" name="矩形 19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连接符 20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" name="组合 21"/>
          <p:cNvGrpSpPr/>
          <p:nvPr/>
        </p:nvGrpSpPr>
        <p:grpSpPr>
          <a:xfrm>
            <a:off x="3569403" y="3460885"/>
            <a:ext cx="685002" cy="276999"/>
            <a:chOff x="-4107133" y="10215563"/>
            <a:chExt cx="685002" cy="276999"/>
          </a:xfrm>
        </p:grpSpPr>
        <p:sp>
          <p:nvSpPr>
            <p:cNvPr id="23" name="矩形 22"/>
            <p:cNvSpPr/>
            <p:nvPr/>
          </p:nvSpPr>
          <p:spPr>
            <a:xfrm>
              <a:off x="-4107133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接连接符 2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矩形 24"/>
          <p:cNvSpPr/>
          <p:nvPr/>
        </p:nvSpPr>
        <p:spPr>
          <a:xfrm>
            <a:off x="4408574" y="4085946"/>
            <a:ext cx="1332779" cy="306155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947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7</Words>
  <Application>Microsoft Office PowerPoint</Application>
  <PresentationFormat>宽屏</PresentationFormat>
  <Paragraphs>2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7</cp:revision>
  <dcterms:created xsi:type="dcterms:W3CDTF">2024-02-08T04:45:53Z</dcterms:created>
  <dcterms:modified xsi:type="dcterms:W3CDTF">2024-02-12T00:39:12Z</dcterms:modified>
</cp:coreProperties>
</file>